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914" y="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DCB7F4-9904-5505-D2E1-2D7B1EDCE3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1C64FBC-FB89-B6A0-1850-06FA42E805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61197A-F494-7A27-BCC5-9C474B6DC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18D1BD-D22D-66F9-0227-2470C97E0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536569-4C22-5E72-706D-381A80CD1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585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9D9FE9-EF00-A943-193C-329009261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D19156-3277-62F9-81F1-1E55665673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2AB860-5788-9FBA-608E-950B45855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235818-1631-C875-AC08-CF60111F0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3BD11F-5BFD-229E-8611-86FC68657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9851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7F80D21-18CD-51FF-F4A6-B3AE8DD599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4F78CC-011D-F448-23CC-8C7A86144A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6B6E4B-87E0-D236-8AAE-286C9A3A6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69CDB1-E83C-65E5-B1D8-D9A52A50E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30D1E8-7C2F-B3F3-B04A-AABE5E7DC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553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CB64B0-B984-6F05-D8BC-1FC8F75FC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B80DEE-F9A0-A97B-6B90-12E322730A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47E474-388C-E9D7-75CC-CB8E46A32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E696BC-DE64-D4E5-C050-E99463207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A912EB-E306-DF81-CF6F-399D2E448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5957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528750-6D0F-EA2D-6AFE-8411EC3B9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CFF124E-C7F6-1994-664E-3D37B09D22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770CA9-36FE-942C-5476-F3A0E5289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76AEB1-B0F0-17AF-53B3-D0C90418B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7421F3-CDD4-5020-031C-9591DDB06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6320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6A7C39-DB90-4AF3-7CB8-E7335EDB30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FE2FAC-9BDC-44A3-57C4-1BD30E75A5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BE5D58-9D4C-685F-BA37-0FA046F727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8D38AE-F7AB-328A-53D6-A9BCDF350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C7ECAF-D487-02F6-272B-25C08666B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2FC246-7E34-904C-7A65-102D911FA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59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6453DD-1C99-5D76-4EE8-5D861436E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02835F-2CB8-7832-91E1-22A2CEEC0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4AE1C6-B741-EA4F-F0A1-89204EF778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7B04FA8-6D64-3805-EA05-C2F239A424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8A25784-0361-D987-7384-E1237AFD99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A8CB82F-D956-8A05-53B9-F0D75C2CF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B19B6D-3ED9-6DDE-151F-17A6124C7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ACD6FDC-EC60-6865-6D81-5112C0AB7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175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467A69-C2F5-366E-5695-D6C01FBEED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032C9E4-AE55-CC75-1FFD-7A70DEDB4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55384A6-4426-90D6-7423-E867CB1C7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5F79CC7-F59B-8A11-70F9-F13BC9E3A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342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BC8B527-786C-91A3-09D1-36E969EF7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DDC1AC0-52F8-4213-3F33-E881ADBFE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12FC2C7-F43C-50D1-6CA6-6DBDE2AFF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17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2F3A1C-FAC6-FC05-E1B2-EF0ACEC56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2AE22B-3DF8-3630-4EB0-FE31F046D8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53AF328-DA6E-EAC4-6D6E-2F473A17CA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B25292B-E98F-56C5-9176-975767298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0672FD-E233-4F1F-F8F6-30C44A2DA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8975E8-46FA-2553-FF94-7F2DCAAFF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9433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FD7C00-A833-0CB0-96E7-55A753F9D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B9067AF-22A2-37FB-55DA-7038743198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8A97CE-AF2A-3246-1518-32409F793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72F5F7-2584-94C1-A37C-F42689517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A66E97-6DEF-D51D-DD0E-68BACA46F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087C5C-9EF1-C86F-0374-0EFF742B6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999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8741197-8C32-E26A-FB7C-703CE3591E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959833-71B0-C340-CC7B-6C66C2D6AC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2FB709-6531-B029-7A0C-1DCB0E95CF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5AB61-7BB6-4960-850B-86DECC1E715F}" type="datetimeFigureOut">
              <a:rPr lang="zh-CN" altLang="en-US" smtClean="0"/>
              <a:t>2025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46CCC2-BA3C-FC3F-F542-511876D330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A12806-8B02-6B84-B559-7BE4CDA9E8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924B2C-1393-45C8-A4A4-A9919B605C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041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745295B5-9E74-FEEF-6D75-AF79E5682BB5}"/>
              </a:ext>
            </a:extLst>
          </p:cNvPr>
          <p:cNvSpPr txBox="1"/>
          <p:nvPr/>
        </p:nvSpPr>
        <p:spPr>
          <a:xfrm>
            <a:off x="85523" y="0"/>
            <a:ext cx="609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ublished data in Fig 5C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B805AE0-BD71-98C8-9ACD-F358ACBE81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1635" y="470237"/>
            <a:ext cx="6761824" cy="6022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4716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F19914C-8D89-A92D-DB13-249B9B8F6592}"/>
              </a:ext>
            </a:extLst>
          </p:cNvPr>
          <p:cNvSpPr txBox="1"/>
          <p:nvPr/>
        </p:nvSpPr>
        <p:spPr>
          <a:xfrm>
            <a:off x="85523" y="0"/>
            <a:ext cx="609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w data 1 for Fig 5C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49E3F609-1FC2-36C4-54D4-38C5AB7661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3976446"/>
              </p:ext>
            </p:extLst>
          </p:nvPr>
        </p:nvGraphicFramePr>
        <p:xfrm>
          <a:off x="3794500" y="0"/>
          <a:ext cx="7358689" cy="71950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2909">
                  <a:extLst>
                    <a:ext uri="{9D8B030D-6E8A-4147-A177-3AD203B41FA5}">
                      <a16:colId xmlns:a16="http://schemas.microsoft.com/office/drawing/2014/main" val="2190492201"/>
                    </a:ext>
                  </a:extLst>
                </a:gridCol>
                <a:gridCol w="1376445">
                  <a:extLst>
                    <a:ext uri="{9D8B030D-6E8A-4147-A177-3AD203B41FA5}">
                      <a16:colId xmlns:a16="http://schemas.microsoft.com/office/drawing/2014/main" val="469934855"/>
                    </a:ext>
                  </a:extLst>
                </a:gridCol>
                <a:gridCol w="1376445">
                  <a:extLst>
                    <a:ext uri="{9D8B030D-6E8A-4147-A177-3AD203B41FA5}">
                      <a16:colId xmlns:a16="http://schemas.microsoft.com/office/drawing/2014/main" val="2867267851"/>
                    </a:ext>
                  </a:extLst>
                </a:gridCol>
                <a:gridCol w="1376445">
                  <a:extLst>
                    <a:ext uri="{9D8B030D-6E8A-4147-A177-3AD203B41FA5}">
                      <a16:colId xmlns:a16="http://schemas.microsoft.com/office/drawing/2014/main" val="2394048132"/>
                    </a:ext>
                  </a:extLst>
                </a:gridCol>
                <a:gridCol w="1376445">
                  <a:extLst>
                    <a:ext uri="{9D8B030D-6E8A-4147-A177-3AD203B41FA5}">
                      <a16:colId xmlns:a16="http://schemas.microsoft.com/office/drawing/2014/main" val="1813896825"/>
                    </a:ext>
                  </a:extLst>
                </a:gridCol>
              </a:tblGrid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7053955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82.96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46.41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60.62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6.84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33282187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871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860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978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2935899394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722960802"/>
                  </a:ext>
                </a:extLst>
              </a:tr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18924457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ho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AKT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82.0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66.82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36.11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28.26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01115855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3354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216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3554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999269363"/>
                  </a:ext>
                </a:extLst>
              </a:tr>
              <a:tr h="385206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AKT</a:t>
                      </a:r>
                      <a:endParaRPr lang="en-US" altLang="zh-CN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4152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910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507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43141063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41516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9105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5077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266687223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519986381"/>
                  </a:ext>
                </a:extLst>
              </a:tr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568635616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-AKT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4.93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3.574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1.782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52.54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2360234764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921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312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874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38560835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66362315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al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T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7580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094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4105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23605439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810407742"/>
                  </a:ext>
                </a:extLst>
              </a:tr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5838332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ERK1/2</a:t>
                      </a:r>
                      <a:endParaRPr lang="en-US" altLang="zh-CN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97.37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7.54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20.174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8.4692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252726009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978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175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305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104013251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3172321089"/>
                  </a:ext>
                </a:extLst>
              </a:tr>
              <a:tr h="385206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ERK1/2</a:t>
                      </a:r>
                      <a:endParaRPr lang="en-US" altLang="zh-CN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434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129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141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811492615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221144607"/>
                  </a:ext>
                </a:extLst>
              </a:tr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81223401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al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ERK1/2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05.92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8.354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5.77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64.113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309567191"/>
                  </a:ext>
                </a:extLst>
              </a:tr>
              <a:tr h="385206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-ERK1/2</a:t>
                      </a:r>
                      <a:endParaRPr lang="en-US" altLang="zh-CN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426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01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3532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4242839887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281792715"/>
                  </a:ext>
                </a:extLst>
              </a:tr>
              <a:tr h="19611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55516524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8.988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12.11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2182354342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8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80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741228257"/>
                  </a:ext>
                </a:extLst>
              </a:tr>
              <a:tr h="1947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8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561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0903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835" marR="4835" marT="4835" marB="0" anchor="ctr"/>
                </a:tc>
                <a:extLst>
                  <a:ext uri="{0D108BD9-81ED-4DB2-BD59-A6C34878D82A}">
                    <a16:rowId xmlns:a16="http://schemas.microsoft.com/office/drawing/2014/main" val="11230061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0917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27</Words>
  <Application>Microsoft Office PowerPoint</Application>
  <PresentationFormat>宽屏</PresentationFormat>
  <Paragraphs>9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7</dc:creator>
  <cp:lastModifiedBy>007</cp:lastModifiedBy>
  <cp:revision>8</cp:revision>
  <dcterms:created xsi:type="dcterms:W3CDTF">2022-06-10T07:56:22Z</dcterms:created>
  <dcterms:modified xsi:type="dcterms:W3CDTF">2025-10-01T15:51:16Z</dcterms:modified>
</cp:coreProperties>
</file>